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206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CAD13-D2AF-4087-8D0B-7C24BD6D7397}" type="datetimeFigureOut">
              <a:rPr lang="en-IN" smtClean="0"/>
              <a:pPr/>
              <a:t>07-05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0BEDE-DB9A-46F8-AC87-8D98282D9A31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331640" y="188640"/>
            <a:ext cx="6120000" cy="5472419"/>
            <a:chOff x="1331640" y="764704"/>
            <a:chExt cx="6120000" cy="547241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331640" y="764704"/>
              <a:ext cx="6120000" cy="54724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" name="TextBox 2"/>
            <p:cNvSpPr txBox="1"/>
            <p:nvPr/>
          </p:nvSpPr>
          <p:spPr>
            <a:xfrm rot="3889742">
              <a:off x="4840593" y="3241517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itchFamily="34" charset="0"/>
                  <a:cs typeface="Arial" pitchFamily="34" charset="0"/>
                </a:rPr>
                <a:t>Clade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I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 rot="826780">
              <a:off x="5456234" y="2308601"/>
              <a:ext cx="6383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itchFamily="34" charset="0"/>
                  <a:cs typeface="Arial" pitchFamily="34" charset="0"/>
                </a:rPr>
                <a:t>Clade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II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251893">
              <a:off x="4881794" y="1956704"/>
              <a:ext cx="6735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itchFamily="34" charset="0"/>
                  <a:cs typeface="Arial" pitchFamily="34" charset="0"/>
                </a:rPr>
                <a:t>Clade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III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5678966">
              <a:off x="4045101" y="3703152"/>
              <a:ext cx="6880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itchFamily="34" charset="0"/>
                  <a:cs typeface="Arial" pitchFamily="34" charset="0"/>
                </a:rPr>
                <a:t>Clade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IV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21048867">
              <a:off x="3524754" y="3328831"/>
              <a:ext cx="6527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 smtClean="0">
                  <a:latin typeface="Arial" pitchFamily="34" charset="0"/>
                  <a:cs typeface="Arial" pitchFamily="34" charset="0"/>
                </a:rPr>
                <a:t>Clade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V</a:t>
              </a:r>
              <a:endParaRPr lang="en-IN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331641" y="5949280"/>
            <a:ext cx="741682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hylogenetic relationships among Arabidopsis and rice NCX proteins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root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ree generated using MEGA6 software using the Neighbor-joining method with 1000 bootstrap replicates. NCX proteins are categorized into five different clades depending upon the relative sequence homology of each member of the clades. Each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lad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s denoted by different color shading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7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IL</dc:creator>
  <cp:lastModifiedBy>Lenovo</cp:lastModifiedBy>
  <cp:revision>5</cp:revision>
  <dcterms:created xsi:type="dcterms:W3CDTF">2015-04-06T12:57:33Z</dcterms:created>
  <dcterms:modified xsi:type="dcterms:W3CDTF">2015-05-07T07:36:12Z</dcterms:modified>
</cp:coreProperties>
</file>